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12192000" cy="6858000"/>
  <p:notesSz cx="6858000" cy="9144000"/>
  <p:defaultTextStyle>
    <a:defPPr>
      <a:defRPr lang="en-TH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58"/>
    <p:restoredTop sz="95794"/>
  </p:normalViewPr>
  <p:slideViewPr>
    <p:cSldViewPr snapToGrid="0">
      <p:cViewPr>
        <p:scale>
          <a:sx n="80" d="100"/>
          <a:sy n="80" d="100"/>
        </p:scale>
        <p:origin x="1784" y="8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T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A366D2-FD74-E044-B454-6109D4593A5C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TH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BE0EB0-2D1A-A444-98E1-A6F8B977B45E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1675051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TH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1BE0EB0-2D1A-A444-98E1-A6F8B977B45E}" type="slidenum">
              <a:rPr lang="en-TH" smtClean="0"/>
              <a:t>1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6396331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CBEF7B-1D14-300C-6325-6590CA971F0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F6719AD-0614-5AD7-6464-6273DAF6B28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DA2978-A9AF-6362-16B8-4FF41530CD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17ED-8C7C-2042-A204-4F3E0371F855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27CC51-90DD-FB24-E098-7CE3D850C6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379E2C-BA01-3DAE-CDEC-C0B4CDF122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BA31FC-A3A9-3C4D-8408-174BA64DCC7A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4157632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CFB236-A120-FF15-9E0D-01DD33D807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93D5D75-5D4F-725D-5AE6-C56DD7145A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16686F-EF53-CC39-B24D-6B919D89A7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17ED-8C7C-2042-A204-4F3E0371F855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1C0A08-A3B5-BC14-13BA-AFB556C5F8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EAC82A-53B3-DBED-7A3A-D616A7D519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BA31FC-A3A9-3C4D-8408-174BA64DCC7A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65987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282B224-D09D-B875-63D8-FB40DBF845E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4357B1D-906E-0E31-20FD-C7ECBDC9C5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2B6481-19CD-98A6-4893-2CE44771E2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17ED-8C7C-2042-A204-4F3E0371F855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594F74-B028-2E80-89FE-119F83FD09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6C367F-614E-92B4-8253-D0A0760327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BA31FC-A3A9-3C4D-8408-174BA64DCC7A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7495369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19220D-700A-0771-BEEC-412FA8AD6C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1FDADA-23E1-4225-8CC7-38D2F7997D5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0C0881-0278-7A89-EA94-17603616FA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17ED-8C7C-2042-A204-4F3E0371F855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E455BD-B614-9ECE-BC72-C616E78A24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5AF29D-A532-0073-29B7-8A616BCCB3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BA31FC-A3A9-3C4D-8408-174BA64DCC7A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40099282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107D30-8AE6-8099-8034-16A0C43EFB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A6EF07-ACD1-67BD-79BF-F7EC683377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FC1DC9-54AB-0071-CDE3-A4CA7EA673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17ED-8C7C-2042-A204-4F3E0371F855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2420B6-BCEA-8CFC-A86C-8FA276AFD3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3AFAAB-DFF9-349B-8480-8DE642D6BF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BA31FC-A3A9-3C4D-8408-174BA64DCC7A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839646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80DEE6-2B7D-B61D-A11F-A6BFCB2E31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A75FBA-2B46-438C-1C3F-93F5B0DFADA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4BEEA71-2209-4D2A-9D7E-0A292140D4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0FF7C65-E951-A45A-562B-A98A1F9A9F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17ED-8C7C-2042-A204-4F3E0371F855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33F0E2-E32B-584F-1D7A-2515FB7B8D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77954AB-3F0B-8B1B-02D9-246B37BFFC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BA31FC-A3A9-3C4D-8408-174BA64DCC7A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8807627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192106-8DC4-5D04-398B-BE1742A705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707D4EE-E4EF-52F0-3939-5323B17F8E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105822-689C-95E5-A9B4-69E8C4CA1F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4516A5A-FF7E-4801-BD4B-CA95D8F8E44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2181833-32D6-7BEF-6F02-D6E3582DC5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B9E1BC0-4803-A552-DFE5-16705CFA28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17ED-8C7C-2042-A204-4F3E0371F855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FDD4BC2-624B-2FB2-BCC0-9D10440B84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18936A6-F3CD-C548-FD32-62BE768151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BA31FC-A3A9-3C4D-8408-174BA64DCC7A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5435549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D6C945-E204-59F4-7DA6-ADC6D3CC22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3355BE5-FC13-558F-FE57-6AD4FE3164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17ED-8C7C-2042-A204-4F3E0371F855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288F271-CC18-C695-5389-424B2A66F7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1CD21C8-E07C-28A0-B256-9E6990CB99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BA31FC-A3A9-3C4D-8408-174BA64DCC7A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5631996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C7FBFA8-8E92-2B03-DF9B-654F35B8E1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17ED-8C7C-2042-A204-4F3E0371F855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56A87C8-917D-642B-D84B-905B2C46CA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F138C54-CFB4-836D-3D47-5DB7972636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BA31FC-A3A9-3C4D-8408-174BA64DCC7A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4160486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97B866-C7EA-3626-3A33-30C9079DCF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C58741-3CBB-3424-E1C0-B74B6EF1D47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6675A19-9C34-5BE9-7AF4-53C3ADBF2F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42C1FE-D3C7-FFAA-15A2-68BB8ED8C7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17ED-8C7C-2042-A204-4F3E0371F855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0BE521-509B-3E02-9C99-32F592B515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BA4578-4BCA-63E4-D334-F4C64A693C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BA31FC-A3A9-3C4D-8408-174BA64DCC7A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2116636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8BAB82-2004-FB12-4F39-E2220EF0E5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2CFCFD-4814-0332-56BE-ACFD078E24C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T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85CA3E-7F62-E21C-FBD6-2396DA67DE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5C4C58-6EEF-D209-44D9-2EF2FEB83C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17ED-8C7C-2042-A204-4F3E0371F855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C8FB51-AFDF-B05C-81A3-302BA407C2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6AA2FC-E2B6-2753-06E2-74092DE240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BA31FC-A3A9-3C4D-8408-174BA64DCC7A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4329432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6034C91-9CA1-1FCF-7C3C-4F1AD96400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76A8D7-CCEF-375A-B253-CBBE5A5057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96112F-CF25-CF06-8CAD-7533F356C67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AF17ED-8C7C-2042-A204-4F3E0371F855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24F46E-C22F-FD1D-AA8C-AAEEF47F2BA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F59CE4-550D-6476-9A42-587D27FCD4A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BA31FC-A3A9-3C4D-8408-174BA64DCC7A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977502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TH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C736283-2898-2779-D179-8B2A9D2920CE}"/>
              </a:ext>
            </a:extLst>
          </p:cNvPr>
          <p:cNvSpPr txBox="1"/>
          <p:nvPr/>
        </p:nvSpPr>
        <p:spPr>
          <a:xfrm>
            <a:off x="0" y="3591190"/>
            <a:ext cx="12192000" cy="6690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sz="28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Inverted gel electrophoresis image</a:t>
            </a:r>
            <a:endParaRPr lang="en-TH" sz="2800" b="1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1AD9618-72E4-46F7-289E-BDAC6B009D02}"/>
              </a:ext>
            </a:extLst>
          </p:cNvPr>
          <p:cNvSpPr txBox="1"/>
          <p:nvPr/>
        </p:nvSpPr>
        <p:spPr>
          <a:xfrm>
            <a:off x="0" y="2467094"/>
            <a:ext cx="12192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3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Additional File 5: Figure S3</a:t>
            </a:r>
            <a:r>
              <a:rPr lang="en-US" sz="3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 </a:t>
            </a:r>
            <a:endParaRPr lang="en-TH" sz="3200" dirty="0"/>
          </a:p>
        </p:txBody>
      </p:sp>
    </p:spTree>
    <p:extLst>
      <p:ext uri="{BB962C8B-B14F-4D97-AF65-F5344CB8AC3E}">
        <p14:creationId xmlns:p14="http://schemas.microsoft.com/office/powerpoint/2010/main" val="19707778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19DD8A8-83E7-9D1A-2D09-762144E402C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379321"/>
            <a:ext cx="7772400" cy="512324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931074B-DDCF-9B0A-AAF1-76D98A27D60F}"/>
              </a:ext>
            </a:extLst>
          </p:cNvPr>
          <p:cNvSpPr txBox="1"/>
          <p:nvPr/>
        </p:nvSpPr>
        <p:spPr>
          <a:xfrm>
            <a:off x="707136" y="5352365"/>
            <a:ext cx="11289792" cy="11546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6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itional File 5: Figure S3</a:t>
            </a:r>
            <a:r>
              <a:rPr lang="en-TH" sz="16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6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verted gel electrophoresis image of Additional File 4: Figure S2 (D). </a:t>
            </a:r>
            <a:r>
              <a:rPr lang="en-TH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ane M: 1 kb ladder, Lane 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C: negative control, </a:t>
            </a:r>
            <a:r>
              <a:rPr lang="en-TH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anes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TH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–</a:t>
            </a:r>
            <a:r>
              <a:rPr lang="en-TH" sz="16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0: </a:t>
            </a:r>
            <a:r>
              <a:rPr lang="en-US" sz="16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. </a:t>
            </a:r>
            <a:r>
              <a:rPr lang="en-US" sz="16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ichui</a:t>
            </a:r>
            <a:r>
              <a:rPr lang="en-US" sz="16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ositive fecal sample IDs Ht01</a:t>
            </a:r>
            <a:r>
              <a:rPr lang="en-US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–Ht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, </a:t>
            </a:r>
            <a:r>
              <a:rPr lang="en-TH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ane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C: positive control. T</a:t>
            </a:r>
            <a:r>
              <a:rPr lang="en-TH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 target amplicon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 were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TH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81 bp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red arrowhead). </a:t>
            </a:r>
            <a:endParaRPr lang="en-TH" sz="1600" b="1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45225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79</Words>
  <Application>Microsoft Macintosh PowerPoint</Application>
  <PresentationFormat>Widescreen</PresentationFormat>
  <Paragraphs>4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rawan Phuphisut</dc:creator>
  <cp:lastModifiedBy>Orawan Phuphisut</cp:lastModifiedBy>
  <cp:revision>11</cp:revision>
  <dcterms:created xsi:type="dcterms:W3CDTF">2023-08-22T03:59:45Z</dcterms:created>
  <dcterms:modified xsi:type="dcterms:W3CDTF">2023-12-27T03:59:04Z</dcterms:modified>
</cp:coreProperties>
</file>